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DE66F80-FBF8-45D1-85E5-FC6893E44409}" v="254" dt="2022-01-10T00:47:12.71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39" autoAdjust="0"/>
    <p:restoredTop sz="94660"/>
  </p:normalViewPr>
  <p:slideViewPr>
    <p:cSldViewPr snapToGrid="0">
      <p:cViewPr>
        <p:scale>
          <a:sx n="100" d="100"/>
          <a:sy n="100" d="100"/>
        </p:scale>
        <p:origin x="1920" y="-19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xandre" userId="2b2fb5af-1a8e-42b9-9a1c-9724d1b34ce9" providerId="ADAL" clId="{CDE66F80-FBF8-45D1-85E5-FC6893E44409}"/>
    <pc:docChg chg="undo custSel modSld">
      <pc:chgData name="Alexandre" userId="2b2fb5af-1a8e-42b9-9a1c-9724d1b34ce9" providerId="ADAL" clId="{CDE66F80-FBF8-45D1-85E5-FC6893E44409}" dt="2022-01-10T00:47:04.173" v="2858"/>
      <pc:docMkLst>
        <pc:docMk/>
      </pc:docMkLst>
      <pc:sldChg chg="addSp delSp modSp mod">
        <pc:chgData name="Alexandre" userId="2b2fb5af-1a8e-42b9-9a1c-9724d1b34ce9" providerId="ADAL" clId="{CDE66F80-FBF8-45D1-85E5-FC6893E44409}" dt="2022-01-10T00:47:04.173" v="2858"/>
        <pc:sldMkLst>
          <pc:docMk/>
          <pc:sldMk cId="1821317616" sldId="256"/>
        </pc:sldMkLst>
        <pc:spChg chg="add mod topLvl">
          <ac:chgData name="Alexandre" userId="2b2fb5af-1a8e-42b9-9a1c-9724d1b34ce9" providerId="ADAL" clId="{CDE66F80-FBF8-45D1-85E5-FC6893E44409}" dt="2022-01-10T00:46:18.407" v="2854" actId="164"/>
          <ac:spMkLst>
            <pc:docMk/>
            <pc:sldMk cId="1821317616" sldId="256"/>
            <ac:spMk id="5" creationId="{BD72F688-883E-4602-8A13-572552DFF8AB}"/>
          </ac:spMkLst>
        </pc:spChg>
        <pc:spChg chg="add mod topLvl">
          <ac:chgData name="Alexandre" userId="2b2fb5af-1a8e-42b9-9a1c-9724d1b34ce9" providerId="ADAL" clId="{CDE66F80-FBF8-45D1-85E5-FC6893E44409}" dt="2022-01-10T00:42:00.236" v="2810" actId="164"/>
          <ac:spMkLst>
            <pc:docMk/>
            <pc:sldMk cId="1821317616" sldId="256"/>
            <ac:spMk id="6" creationId="{661C04A4-FE58-4D57-B651-B9523EE75817}"/>
          </ac:spMkLst>
        </pc:spChg>
        <pc:spChg chg="add mod topLvl">
          <ac:chgData name="Alexandre" userId="2b2fb5af-1a8e-42b9-9a1c-9724d1b34ce9" providerId="ADAL" clId="{CDE66F80-FBF8-45D1-85E5-FC6893E44409}" dt="2022-01-10T00:42:00.236" v="2810" actId="164"/>
          <ac:spMkLst>
            <pc:docMk/>
            <pc:sldMk cId="1821317616" sldId="256"/>
            <ac:spMk id="7" creationId="{E7349E34-48B8-483C-957E-E3ED32F42A42}"/>
          </ac:spMkLst>
        </pc:spChg>
        <pc:spChg chg="add mod topLvl">
          <ac:chgData name="Alexandre" userId="2b2fb5af-1a8e-42b9-9a1c-9724d1b34ce9" providerId="ADAL" clId="{CDE66F80-FBF8-45D1-85E5-FC6893E44409}" dt="2022-01-10T00:42:00.236" v="2810" actId="164"/>
          <ac:spMkLst>
            <pc:docMk/>
            <pc:sldMk cId="1821317616" sldId="256"/>
            <ac:spMk id="8" creationId="{150DDF74-4A91-41CC-AE3F-47CFB44FC9BD}"/>
          </ac:spMkLst>
        </pc:spChg>
        <pc:spChg chg="add mod">
          <ac:chgData name="Alexandre" userId="2b2fb5af-1a8e-42b9-9a1c-9724d1b34ce9" providerId="ADAL" clId="{CDE66F80-FBF8-45D1-85E5-FC6893E44409}" dt="2022-01-10T00:41:54.297" v="2809" actId="165"/>
          <ac:spMkLst>
            <pc:docMk/>
            <pc:sldMk cId="1821317616" sldId="256"/>
            <ac:spMk id="9" creationId="{1B3924FE-3412-4898-9A8B-FE1E3ACC05F9}"/>
          </ac:spMkLst>
        </pc:spChg>
        <pc:spChg chg="add mod">
          <ac:chgData name="Alexandre" userId="2b2fb5af-1a8e-42b9-9a1c-9724d1b34ce9" providerId="ADAL" clId="{CDE66F80-FBF8-45D1-85E5-FC6893E44409}" dt="2022-01-10T00:41:54.297" v="2809" actId="165"/>
          <ac:spMkLst>
            <pc:docMk/>
            <pc:sldMk cId="1821317616" sldId="256"/>
            <ac:spMk id="10" creationId="{AFB044B3-D86F-4E0A-AA18-CB69258BC018}"/>
          </ac:spMkLst>
        </pc:spChg>
        <pc:spChg chg="add mod">
          <ac:chgData name="Alexandre" userId="2b2fb5af-1a8e-42b9-9a1c-9724d1b34ce9" providerId="ADAL" clId="{CDE66F80-FBF8-45D1-85E5-FC6893E44409}" dt="2022-01-10T00:41:54.297" v="2809" actId="165"/>
          <ac:spMkLst>
            <pc:docMk/>
            <pc:sldMk cId="1821317616" sldId="256"/>
            <ac:spMk id="11" creationId="{912B8489-6C13-4412-88F0-5F3A6528BA54}"/>
          </ac:spMkLst>
        </pc:spChg>
        <pc:spChg chg="add mod topLvl">
          <ac:chgData name="Alexandre" userId="2b2fb5af-1a8e-42b9-9a1c-9724d1b34ce9" providerId="ADAL" clId="{CDE66F80-FBF8-45D1-85E5-FC6893E44409}" dt="2022-01-10T00:42:00.236" v="2810" actId="164"/>
          <ac:spMkLst>
            <pc:docMk/>
            <pc:sldMk cId="1821317616" sldId="256"/>
            <ac:spMk id="12" creationId="{061D4689-C0CA-4D36-93C7-C8BD2133093D}"/>
          </ac:spMkLst>
        </pc:spChg>
        <pc:spChg chg="add del mod">
          <ac:chgData name="Alexandre" userId="2b2fb5af-1a8e-42b9-9a1c-9724d1b34ce9" providerId="ADAL" clId="{CDE66F80-FBF8-45D1-85E5-FC6893E44409}" dt="2022-01-10T00:09:34.119" v="1311" actId="478"/>
          <ac:spMkLst>
            <pc:docMk/>
            <pc:sldMk cId="1821317616" sldId="256"/>
            <ac:spMk id="13" creationId="{D06514E7-EFEC-4909-B9BF-45B9741426EC}"/>
          </ac:spMkLst>
        </pc:spChg>
        <pc:spChg chg="add mod">
          <ac:chgData name="Alexandre" userId="2b2fb5af-1a8e-42b9-9a1c-9724d1b34ce9" providerId="ADAL" clId="{CDE66F80-FBF8-45D1-85E5-FC6893E44409}" dt="2022-01-10T00:41:54.297" v="2809" actId="165"/>
          <ac:spMkLst>
            <pc:docMk/>
            <pc:sldMk cId="1821317616" sldId="256"/>
            <ac:spMk id="14" creationId="{988BB0AB-E584-4747-940C-F44566AB75C8}"/>
          </ac:spMkLst>
        </pc:spChg>
        <pc:spChg chg="add del mod">
          <ac:chgData name="Alexandre" userId="2b2fb5af-1a8e-42b9-9a1c-9724d1b34ce9" providerId="ADAL" clId="{CDE66F80-FBF8-45D1-85E5-FC6893E44409}" dt="2022-01-10T00:41:31.709" v="2805" actId="478"/>
          <ac:spMkLst>
            <pc:docMk/>
            <pc:sldMk cId="1821317616" sldId="256"/>
            <ac:spMk id="17" creationId="{407AB6AB-800C-451D-AC7E-17E55C07813C}"/>
          </ac:spMkLst>
        </pc:spChg>
        <pc:grpChg chg="add mod topLvl">
          <ac:chgData name="Alexandre" userId="2b2fb5af-1a8e-42b9-9a1c-9724d1b34ce9" providerId="ADAL" clId="{CDE66F80-FBF8-45D1-85E5-FC6893E44409}" dt="2022-01-10T00:42:00.236" v="2810" actId="164"/>
          <ac:grpSpMkLst>
            <pc:docMk/>
            <pc:sldMk cId="1821317616" sldId="256"/>
            <ac:grpSpMk id="15" creationId="{489229A7-6982-493F-96C3-1240DB9021AF}"/>
          </ac:grpSpMkLst>
        </pc:grpChg>
        <pc:grpChg chg="add del mod">
          <ac:chgData name="Alexandre" userId="2b2fb5af-1a8e-42b9-9a1c-9724d1b34ce9" providerId="ADAL" clId="{CDE66F80-FBF8-45D1-85E5-FC6893E44409}" dt="2022-01-10T00:41:54.297" v="2809" actId="165"/>
          <ac:grpSpMkLst>
            <pc:docMk/>
            <pc:sldMk cId="1821317616" sldId="256"/>
            <ac:grpSpMk id="16" creationId="{0A720933-4B3F-41AD-AC4E-2E69B776B17E}"/>
          </ac:grpSpMkLst>
        </pc:grpChg>
        <pc:grpChg chg="add mod">
          <ac:chgData name="Alexandre" userId="2b2fb5af-1a8e-42b9-9a1c-9724d1b34ce9" providerId="ADAL" clId="{CDE66F80-FBF8-45D1-85E5-FC6893E44409}" dt="2022-01-10T00:44:52.840" v="2846" actId="164"/>
          <ac:grpSpMkLst>
            <pc:docMk/>
            <pc:sldMk cId="1821317616" sldId="256"/>
            <ac:grpSpMk id="20" creationId="{6A8F8CB4-58A3-4C24-8687-0A7DAEABABDA}"/>
          </ac:grpSpMkLst>
        </pc:grpChg>
        <pc:grpChg chg="add mod">
          <ac:chgData name="Alexandre" userId="2b2fb5af-1a8e-42b9-9a1c-9724d1b34ce9" providerId="ADAL" clId="{CDE66F80-FBF8-45D1-85E5-FC6893E44409}" dt="2022-01-10T00:46:18.407" v="2854" actId="164"/>
          <ac:grpSpMkLst>
            <pc:docMk/>
            <pc:sldMk cId="1821317616" sldId="256"/>
            <ac:grpSpMk id="21" creationId="{A2C27CF8-26B0-49D7-87E2-24A60DA12A61}"/>
          </ac:grpSpMkLst>
        </pc:grpChg>
        <pc:grpChg chg="add mod">
          <ac:chgData name="Alexandre" userId="2b2fb5af-1a8e-42b9-9a1c-9724d1b34ce9" providerId="ADAL" clId="{CDE66F80-FBF8-45D1-85E5-FC6893E44409}" dt="2022-01-10T00:46:46.399" v="2857" actId="1076"/>
          <ac:grpSpMkLst>
            <pc:docMk/>
            <pc:sldMk cId="1821317616" sldId="256"/>
            <ac:grpSpMk id="22" creationId="{EEAE613D-2E73-46A3-BFFC-5AAFA2640653}"/>
          </ac:grpSpMkLst>
        </pc:grpChg>
        <pc:graphicFrameChg chg="mod topLvl">
          <ac:chgData name="Alexandre" userId="2b2fb5af-1a8e-42b9-9a1c-9724d1b34ce9" providerId="ADAL" clId="{CDE66F80-FBF8-45D1-85E5-FC6893E44409}" dt="2022-01-10T00:47:04.173" v="2858"/>
          <ac:graphicFrameMkLst>
            <pc:docMk/>
            <pc:sldMk cId="1821317616" sldId="256"/>
            <ac:graphicFrameMk id="4" creationId="{0F638BA3-A67E-4D13-823B-DF01BF4B92EC}"/>
          </ac:graphicFrameMkLst>
        </pc:graphicFrameChg>
        <pc:picChg chg="add mod modCrop">
          <ac:chgData name="Alexandre" userId="2b2fb5af-1a8e-42b9-9a1c-9724d1b34ce9" providerId="ADAL" clId="{CDE66F80-FBF8-45D1-85E5-FC6893E44409}" dt="2022-01-10T00:45:32.400" v="2850" actId="1035"/>
          <ac:picMkLst>
            <pc:docMk/>
            <pc:sldMk cId="1821317616" sldId="256"/>
            <ac:picMk id="19" creationId="{F52A2ABD-5262-42A7-AB3C-0180BB3E7C3F}"/>
          </ac:picMkLst>
        </pc:pic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74A1-9F96-4A8F-83D1-C95A1593340C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5F65-DC49-4FFF-8F48-E76E8CB775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51611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74A1-9F96-4A8F-83D1-C95A1593340C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5F65-DC49-4FFF-8F48-E76E8CB775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9028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74A1-9F96-4A8F-83D1-C95A1593340C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5F65-DC49-4FFF-8F48-E76E8CB775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7479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74A1-9F96-4A8F-83D1-C95A1593340C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5F65-DC49-4FFF-8F48-E76E8CB775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0834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74A1-9F96-4A8F-83D1-C95A1593340C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5F65-DC49-4FFF-8F48-E76E8CB775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94138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74A1-9F96-4A8F-83D1-C95A1593340C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5F65-DC49-4FFF-8F48-E76E8CB775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25024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74A1-9F96-4A8F-83D1-C95A1593340C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5F65-DC49-4FFF-8F48-E76E8CB775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3593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74A1-9F96-4A8F-83D1-C95A1593340C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5F65-DC49-4FFF-8F48-E76E8CB775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73261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74A1-9F96-4A8F-83D1-C95A1593340C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5F65-DC49-4FFF-8F48-E76E8CB775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2852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74A1-9F96-4A8F-83D1-C95A1593340C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5F65-DC49-4FFF-8F48-E76E8CB775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88650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74A1-9F96-4A8F-83D1-C95A1593340C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5F65-DC49-4FFF-8F48-E76E8CB775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60527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5674A1-9F96-4A8F-83D1-C95A1593340C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E85F65-DC49-4FFF-8F48-E76E8CB775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55056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worm.princeton.edu/" TargetMode="External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png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>
            <a:extLst>
              <a:ext uri="{FF2B5EF4-FFF2-40B4-BE49-F238E27FC236}">
                <a16:creationId xmlns:a16="http://schemas.microsoft.com/office/drawing/2014/main" id="{EEAE613D-2E73-46A3-BFFC-5AAFA2640653}"/>
              </a:ext>
            </a:extLst>
          </p:cNvPr>
          <p:cNvGrpSpPr/>
          <p:nvPr/>
        </p:nvGrpSpPr>
        <p:grpSpPr>
          <a:xfrm>
            <a:off x="583050" y="470316"/>
            <a:ext cx="5691900" cy="8965367"/>
            <a:chOff x="911600" y="543697"/>
            <a:chExt cx="5691900" cy="8965367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BD72F688-883E-4602-8A13-572552DFF8AB}"/>
                </a:ext>
              </a:extLst>
            </p:cNvPr>
            <p:cNvSpPr txBox="1"/>
            <p:nvPr/>
          </p:nvSpPr>
          <p:spPr>
            <a:xfrm>
              <a:off x="911600" y="8185625"/>
              <a:ext cx="5691900" cy="13234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GB" sz="800" b="1" dirty="0"/>
                <a:t>Supplementary </a:t>
              </a:r>
              <a:r>
                <a:rPr lang="en-GB" sz="800" b="1"/>
                <a:t>Figure S3. </a:t>
              </a:r>
              <a:r>
                <a:rPr lang="en-GB" sz="800" b="1" dirty="0"/>
                <a:t>Tissue expression heatmap of </a:t>
              </a:r>
              <a:r>
                <a:rPr lang="en-GB" sz="800" b="1" i="1" dirty="0"/>
                <a:t>C. elegans </a:t>
              </a:r>
              <a:r>
                <a:rPr lang="en-GB" sz="800" b="1" dirty="0"/>
                <a:t>Hedgehog-like (HHL) pathway genes and known genetic interactors. </a:t>
              </a:r>
              <a:r>
                <a:rPr lang="en-GB" sz="800" dirty="0"/>
                <a:t>Genes are ordered based on phylogenetic relationships (cladograms on the left), while tissues are grouped around main physiological systems: neuronal, epithelial, muscular and reproductive. The heatmap was generated by replotting individual gene-tissue heatmap scores downloaded from Worm tissue (</a:t>
              </a:r>
              <a:r>
                <a:rPr lang="en-GB" sz="800" dirty="0">
                  <a:hlinkClick r:id="rId3"/>
                </a:rPr>
                <a:t>https://worm.princeton.edu/</a:t>
              </a:r>
              <a:r>
                <a:rPr lang="en-GB" sz="800" dirty="0"/>
                <a:t>, </a:t>
              </a:r>
              <a:r>
                <a:rPr lang="en-GB" sz="800" dirty="0" err="1"/>
                <a:t>Kaletsky</a:t>
              </a:r>
              <a:r>
                <a:rPr lang="en-GB" sz="800" dirty="0"/>
                <a:t>, Yao et al. 2018) using GraphPad Prism. Genetic interactors appear near ubiquitous. All main systems express both ligands (</a:t>
              </a:r>
              <a:r>
                <a:rPr lang="en-GB" sz="800" i="1" dirty="0" err="1"/>
                <a:t>grd</a:t>
              </a:r>
              <a:r>
                <a:rPr lang="en-GB" sz="800" i="1" dirty="0"/>
                <a:t>-</a:t>
              </a:r>
              <a:r>
                <a:rPr lang="en-GB" sz="800" dirty="0"/>
                <a:t>, </a:t>
              </a:r>
              <a:r>
                <a:rPr lang="en-GB" sz="800" i="1" dirty="0" err="1"/>
                <a:t>grl</a:t>
              </a:r>
              <a:r>
                <a:rPr lang="en-GB" sz="800" i="1" dirty="0"/>
                <a:t>-</a:t>
              </a:r>
              <a:r>
                <a:rPr lang="en-GB" sz="800" dirty="0"/>
                <a:t>, </a:t>
              </a:r>
              <a:r>
                <a:rPr lang="en-GB" sz="800" i="1" dirty="0" err="1"/>
                <a:t>wrt</a:t>
              </a:r>
              <a:r>
                <a:rPr lang="en-GB" sz="800" i="1" dirty="0"/>
                <a:t>-</a:t>
              </a:r>
              <a:r>
                <a:rPr lang="en-GB" sz="800" dirty="0"/>
                <a:t> Hedgehog-related peptides) and receptors (</a:t>
              </a:r>
              <a:r>
                <a:rPr lang="en-GB" sz="800" i="1" dirty="0" err="1"/>
                <a:t>ptr</a:t>
              </a:r>
              <a:r>
                <a:rPr lang="en-GB" sz="800" i="1" dirty="0"/>
                <a:t>-</a:t>
              </a:r>
              <a:r>
                <a:rPr lang="en-GB" sz="800" dirty="0"/>
                <a:t> &amp; </a:t>
              </a:r>
              <a:r>
                <a:rPr lang="en-GB" sz="800" i="1" dirty="0" err="1"/>
                <a:t>ptc</a:t>
              </a:r>
              <a:r>
                <a:rPr lang="en-GB" sz="800" i="1" dirty="0"/>
                <a:t>-</a:t>
              </a:r>
              <a:r>
                <a:rPr lang="en-GB" sz="800" dirty="0"/>
                <a:t> Patched-related receptors). Most HHL pathway genes are found co-expressed in neurones and the hypodermis (boxes 1 &amp; 2, 37 out of 60  HRPs, 11 out of 27 PTRs), while expression in the intestine (box 3, 18 out of 44 </a:t>
              </a:r>
              <a:r>
                <a:rPr lang="en-GB" sz="800" i="1" dirty="0" err="1"/>
                <a:t>grd</a:t>
              </a:r>
              <a:r>
                <a:rPr lang="en-GB" sz="800" i="1" dirty="0"/>
                <a:t>- &amp;</a:t>
              </a:r>
              <a:r>
                <a:rPr lang="en-GB" sz="800" dirty="0"/>
                <a:t> </a:t>
              </a:r>
              <a:r>
                <a:rPr lang="en-GB" sz="800" i="1" dirty="0" err="1"/>
                <a:t>grl</a:t>
              </a:r>
              <a:r>
                <a:rPr lang="en-GB" sz="800" i="1" dirty="0"/>
                <a:t>-, wrt-1/-2/-5/-10</a:t>
              </a:r>
              <a:r>
                <a:rPr lang="en-GB" sz="800" dirty="0"/>
                <a:t>, </a:t>
              </a:r>
              <a:r>
                <a:rPr lang="en-GB" sz="800" i="1" dirty="0"/>
                <a:t>qua-1</a:t>
              </a:r>
              <a:r>
                <a:rPr lang="en-GB" sz="800" dirty="0"/>
                <a:t>, </a:t>
              </a:r>
              <a:r>
                <a:rPr lang="en-GB" sz="800" i="1" dirty="0"/>
                <a:t>ptc-1/-3</a:t>
              </a:r>
              <a:r>
                <a:rPr lang="en-GB" sz="800" dirty="0"/>
                <a:t>, daf-6, </a:t>
              </a:r>
              <a:r>
                <a:rPr lang="en-GB" sz="800" i="1" dirty="0"/>
                <a:t>ptr-4/-21/-24</a:t>
              </a:r>
              <a:r>
                <a:rPr lang="en-GB" sz="800" dirty="0"/>
                <a:t>)</a:t>
              </a:r>
              <a:r>
                <a:rPr lang="en-GB" sz="800" i="1" dirty="0"/>
                <a:t> </a:t>
              </a:r>
              <a:r>
                <a:rPr lang="en-GB" sz="800" dirty="0"/>
                <a:t>or the gonad (box 4, </a:t>
              </a:r>
              <a:r>
                <a:rPr lang="en-GB" sz="800" i="1" dirty="0"/>
                <a:t>ptc-1/-3, ptr-2/-8/12, wrt-3 &amp; wrt-5</a:t>
              </a:r>
              <a:r>
                <a:rPr lang="en-GB" sz="800" dirty="0"/>
                <a:t> and no </a:t>
              </a:r>
              <a:r>
                <a:rPr lang="en-GB" sz="800" i="1" dirty="0" err="1"/>
                <a:t>grd</a:t>
              </a:r>
              <a:r>
                <a:rPr lang="en-GB" sz="800" i="1" dirty="0"/>
                <a:t>- </a:t>
              </a:r>
              <a:r>
                <a:rPr lang="en-GB" sz="800" dirty="0"/>
                <a:t>or </a:t>
              </a:r>
              <a:r>
                <a:rPr lang="en-GB" sz="800" i="1" dirty="0" err="1"/>
                <a:t>grl</a:t>
              </a:r>
              <a:r>
                <a:rPr lang="en-GB" sz="800" i="1" dirty="0"/>
                <a:t>-</a:t>
              </a:r>
              <a:r>
                <a:rPr lang="en-GB" sz="800" dirty="0"/>
                <a:t>) is more restricted. The receptors </a:t>
              </a:r>
              <a:r>
                <a:rPr lang="en-GB" sz="800" i="1" dirty="0"/>
                <a:t>ptr-21</a:t>
              </a:r>
              <a:r>
                <a:rPr lang="en-GB" sz="800" dirty="0"/>
                <a:t> &amp; </a:t>
              </a:r>
              <a:r>
                <a:rPr lang="en-GB" sz="800" i="1" dirty="0"/>
                <a:t>ptr-24</a:t>
              </a:r>
              <a:r>
                <a:rPr lang="en-GB" sz="800" dirty="0"/>
                <a:t> appear specific to the intestine amongst other epithelial tissues. 28 out of 87 HRPs + PTRs appear to be hermaphrodite-specific. Within HRPs and PTRs phylogenetic proximity loosely correlates with tissue expression.</a:t>
              </a:r>
            </a:p>
          </p:txBody>
        </p: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A2C27CF8-26B0-49D7-87E2-24A60DA12A61}"/>
                </a:ext>
              </a:extLst>
            </p:cNvPr>
            <p:cNvGrpSpPr/>
            <p:nvPr/>
          </p:nvGrpSpPr>
          <p:grpSpPr>
            <a:xfrm>
              <a:off x="911600" y="543697"/>
              <a:ext cx="5691900" cy="7562335"/>
              <a:chOff x="911600" y="543697"/>
              <a:chExt cx="5691900" cy="7562335"/>
            </a:xfrm>
          </p:grpSpPr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6A8F8CB4-58A3-4C24-8687-0A7DAEABABDA}"/>
                  </a:ext>
                </a:extLst>
              </p:cNvPr>
              <p:cNvGrpSpPr/>
              <p:nvPr/>
            </p:nvGrpSpPr>
            <p:grpSpPr>
              <a:xfrm>
                <a:off x="1065045" y="543697"/>
                <a:ext cx="5538455" cy="7562335"/>
                <a:chOff x="1977162" y="1839497"/>
                <a:chExt cx="4725192" cy="6451887"/>
              </a:xfrm>
            </p:grpSpPr>
            <p:graphicFrame>
              <p:nvGraphicFramePr>
                <p:cNvPr id="4" name="Object 3">
                  <a:extLst>
                    <a:ext uri="{FF2B5EF4-FFF2-40B4-BE49-F238E27FC236}">
                      <a16:creationId xmlns:a16="http://schemas.microsoft.com/office/drawing/2014/main" id="{0F638BA3-A67E-4D13-823B-DF01BF4B92EC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815356383"/>
                    </p:ext>
                  </p:extLst>
                </p:nvPr>
              </p:nvGraphicFramePr>
              <p:xfrm>
                <a:off x="1977162" y="1907403"/>
                <a:ext cx="4725192" cy="6383981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025" name="Prism 9" r:id="rId4" imgW="6876927" imgH="9292409" progId="Prism9.Document">
                        <p:embed/>
                      </p:oleObj>
                    </mc:Choice>
                    <mc:Fallback>
                      <p:oleObj name="Prism 9" r:id="rId4" imgW="6876927" imgH="9292409" progId="Prism9.Document">
                        <p:embed/>
                        <p:pic>
                          <p:nvPicPr>
                            <p:cNvPr id="4" name="Object 3">
                              <a:extLst>
                                <a:ext uri="{FF2B5EF4-FFF2-40B4-BE49-F238E27FC236}">
                                  <a16:creationId xmlns:a16="http://schemas.microsoft.com/office/drawing/2014/main" id="{0F638BA3-A67E-4D13-823B-DF01BF4B92EC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977162" y="1907403"/>
                              <a:ext cx="4725192" cy="6383981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6" name="Rectangle 5">
                  <a:extLst>
                    <a:ext uri="{FF2B5EF4-FFF2-40B4-BE49-F238E27FC236}">
                      <a16:creationId xmlns:a16="http://schemas.microsoft.com/office/drawing/2014/main" id="{661C04A4-FE58-4D57-B651-B9523EE75817}"/>
                    </a:ext>
                  </a:extLst>
                </p:cNvPr>
                <p:cNvSpPr/>
                <p:nvPr/>
              </p:nvSpPr>
              <p:spPr>
                <a:xfrm>
                  <a:off x="4297537" y="2013038"/>
                  <a:ext cx="45720" cy="5482067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7" name="Rectangle 6">
                  <a:extLst>
                    <a:ext uri="{FF2B5EF4-FFF2-40B4-BE49-F238E27FC236}">
                      <a16:creationId xmlns:a16="http://schemas.microsoft.com/office/drawing/2014/main" id="{E7349E34-48B8-483C-957E-E3ED32F42A42}"/>
                    </a:ext>
                  </a:extLst>
                </p:cNvPr>
                <p:cNvSpPr/>
                <p:nvPr/>
              </p:nvSpPr>
              <p:spPr>
                <a:xfrm>
                  <a:off x="4046907" y="2013038"/>
                  <a:ext cx="45719" cy="5482067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8" name="Rectangle 7">
                  <a:extLst>
                    <a:ext uri="{FF2B5EF4-FFF2-40B4-BE49-F238E27FC236}">
                      <a16:creationId xmlns:a16="http://schemas.microsoft.com/office/drawing/2014/main" id="{150DDF74-4A91-41CC-AE3F-47CFB44FC9BD}"/>
                    </a:ext>
                  </a:extLst>
                </p:cNvPr>
                <p:cNvSpPr/>
                <p:nvPr/>
              </p:nvSpPr>
              <p:spPr>
                <a:xfrm>
                  <a:off x="2379179" y="2013038"/>
                  <a:ext cx="45719" cy="5482067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2" name="Rectangle 11">
                  <a:extLst>
                    <a:ext uri="{FF2B5EF4-FFF2-40B4-BE49-F238E27FC236}">
                      <a16:creationId xmlns:a16="http://schemas.microsoft.com/office/drawing/2014/main" id="{061D4689-C0CA-4D36-93C7-C8BD2133093D}"/>
                    </a:ext>
                  </a:extLst>
                </p:cNvPr>
                <p:cNvSpPr/>
                <p:nvPr/>
              </p:nvSpPr>
              <p:spPr>
                <a:xfrm>
                  <a:off x="5623847" y="2013038"/>
                  <a:ext cx="90788" cy="5482067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grpSp>
              <p:nvGrpSpPr>
                <p:cNvPr id="15" name="Group 14">
                  <a:extLst>
                    <a:ext uri="{FF2B5EF4-FFF2-40B4-BE49-F238E27FC236}">
                      <a16:creationId xmlns:a16="http://schemas.microsoft.com/office/drawing/2014/main" id="{489229A7-6982-493F-96C3-1240DB9021AF}"/>
                    </a:ext>
                  </a:extLst>
                </p:cNvPr>
                <p:cNvGrpSpPr/>
                <p:nvPr/>
              </p:nvGrpSpPr>
              <p:grpSpPr>
                <a:xfrm>
                  <a:off x="2279723" y="1839497"/>
                  <a:ext cx="3507499" cy="215444"/>
                  <a:chOff x="2281167" y="801529"/>
                  <a:chExt cx="3507499" cy="215444"/>
                </a:xfrm>
              </p:grpSpPr>
              <p:sp>
                <p:nvSpPr>
                  <p:cNvPr id="9" name="TextBox 8">
                    <a:extLst>
                      <a:ext uri="{FF2B5EF4-FFF2-40B4-BE49-F238E27FC236}">
                        <a16:creationId xmlns:a16="http://schemas.microsoft.com/office/drawing/2014/main" id="{1B3924FE-3412-4898-9A8B-FE1E3ACC05F9}"/>
                      </a:ext>
                    </a:extLst>
                  </p:cNvPr>
                  <p:cNvSpPr txBox="1"/>
                  <p:nvPr/>
                </p:nvSpPr>
                <p:spPr>
                  <a:xfrm>
                    <a:off x="2281167" y="801529"/>
                    <a:ext cx="23596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/>
                      <a:t>1</a:t>
                    </a:r>
                  </a:p>
                </p:txBody>
              </p:sp>
              <p:sp>
                <p:nvSpPr>
                  <p:cNvPr id="10" name="TextBox 9">
                    <a:extLst>
                      <a:ext uri="{FF2B5EF4-FFF2-40B4-BE49-F238E27FC236}">
                        <a16:creationId xmlns:a16="http://schemas.microsoft.com/office/drawing/2014/main" id="{AFB044B3-D86F-4E0A-AA18-CB69258BC018}"/>
                      </a:ext>
                    </a:extLst>
                  </p:cNvPr>
                  <p:cNvSpPr txBox="1"/>
                  <p:nvPr/>
                </p:nvSpPr>
                <p:spPr>
                  <a:xfrm>
                    <a:off x="3953229" y="801529"/>
                    <a:ext cx="23596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/>
                      <a:t>2</a:t>
                    </a:r>
                  </a:p>
                </p:txBody>
              </p:sp>
              <p:sp>
                <p:nvSpPr>
                  <p:cNvPr id="11" name="TextBox 10">
                    <a:extLst>
                      <a:ext uri="{FF2B5EF4-FFF2-40B4-BE49-F238E27FC236}">
                        <a16:creationId xmlns:a16="http://schemas.microsoft.com/office/drawing/2014/main" id="{912B8489-6C13-4412-88F0-5F3A6528BA54}"/>
                      </a:ext>
                    </a:extLst>
                  </p:cNvPr>
                  <p:cNvSpPr txBox="1"/>
                  <p:nvPr/>
                </p:nvSpPr>
                <p:spPr>
                  <a:xfrm>
                    <a:off x="4209890" y="801529"/>
                    <a:ext cx="23596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/>
                      <a:t>3</a:t>
                    </a:r>
                  </a:p>
                </p:txBody>
              </p:sp>
              <p:sp>
                <p:nvSpPr>
                  <p:cNvPr id="14" name="TextBox 13">
                    <a:extLst>
                      <a:ext uri="{FF2B5EF4-FFF2-40B4-BE49-F238E27FC236}">
                        <a16:creationId xmlns:a16="http://schemas.microsoft.com/office/drawing/2014/main" id="{988BB0AB-E584-4747-940C-F44566AB75C8}"/>
                      </a:ext>
                    </a:extLst>
                  </p:cNvPr>
                  <p:cNvSpPr txBox="1"/>
                  <p:nvPr/>
                </p:nvSpPr>
                <p:spPr>
                  <a:xfrm>
                    <a:off x="5552704" y="801529"/>
                    <a:ext cx="23596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/>
                      <a:t>4</a:t>
                    </a:r>
                  </a:p>
                </p:txBody>
              </p:sp>
            </p:grpSp>
          </p:grpSp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F52A2ABD-5262-42A7-AB3C-0180BB3E7C3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t="258"/>
              <a:stretch/>
            </p:blipFill>
            <p:spPr>
              <a:xfrm>
                <a:off x="911600" y="768893"/>
                <a:ext cx="286753" cy="5228047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18213176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13811305467C74494CB40DB3D5262DA" ma:contentTypeVersion="8" ma:contentTypeDescription="Create a new document." ma:contentTypeScope="" ma:versionID="8fc5784638860716a3723dffd2d08673">
  <xsd:schema xmlns:xsd="http://www.w3.org/2001/XMLSchema" xmlns:xs="http://www.w3.org/2001/XMLSchema" xmlns:p="http://schemas.microsoft.com/office/2006/metadata/properties" xmlns:ns2="c0db18e3-4c06-4c9d-ab15-91da0ad61027" targetNamespace="http://schemas.microsoft.com/office/2006/metadata/properties" ma:root="true" ma:fieldsID="e03991102f04ff9dcf3a5d4219758345" ns2:_="">
    <xsd:import namespace="c0db18e3-4c06-4c9d-ab15-91da0ad61027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0db18e3-4c06-4c9d-ab15-91da0ad6102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FB76DD9E-F4FB-4A1B-93C9-CBF739C635BE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37BD2DD5-EAD8-4F14-AA1D-358C498B767E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22146F03-6098-4F80-89C8-142680C54BE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0db18e3-4c06-4c9d-ab15-91da0ad6102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</TotalTime>
  <Words>257</Words>
  <Application>Microsoft Macintosh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andre Benedetto</dc:creator>
  <cp:lastModifiedBy>Alejandra Zarate</cp:lastModifiedBy>
  <cp:revision>2</cp:revision>
  <dcterms:created xsi:type="dcterms:W3CDTF">2022-01-09T23:36:37Z</dcterms:created>
  <dcterms:modified xsi:type="dcterms:W3CDTF">2022-02-28T10:49:1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13811305467C74494CB40DB3D5262DA</vt:lpwstr>
  </property>
</Properties>
</file>